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2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03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0865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486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376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0250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043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7918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5090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501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927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5991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3053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BE4485-309E-471F-A5FF-EF046135106C}" type="datetimeFigureOut">
              <a:rPr kumimoji="1" lang="ja-JP" altLang="en-US" smtClean="0"/>
              <a:t>2016/1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17162-DDDC-4391-94A1-83B7E3592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0317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4641" y="796163"/>
            <a:ext cx="6697066" cy="4277563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213111" y="5195705"/>
            <a:ext cx="88152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>
                <a:latin typeface="Century" panose="02040604050505020304" pitchFamily="18" charset="0"/>
              </a:rPr>
              <a:t>Figure S1 Expression pattern of circadian clock-related genes (SlyLHY, SlyPRR1/TOC1, SlyPRR5, SlyPRR37, SlyPRR73 and SlyGI).</a:t>
            </a:r>
            <a:endParaRPr kumimoji="1" lang="ja-JP" altLang="en-US" sz="1100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143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B27961C4-7695-4580-BF13-6BF51BF4EF54}"/>
</file>

<file path=customXml/itemProps2.xml><?xml version="1.0" encoding="utf-8"?>
<ds:datastoreItem xmlns:ds="http://schemas.openxmlformats.org/officeDocument/2006/customXml" ds:itemID="{37DF6553-1C5F-4914-A627-0E14CF56B169}"/>
</file>

<file path=customXml/itemProps3.xml><?xml version="1.0" encoding="utf-8"?>
<ds:datastoreItem xmlns:ds="http://schemas.openxmlformats.org/officeDocument/2006/customXml" ds:itemID="{5A1129BF-8DD5-447F-B1D9-4F1E05F16448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1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Century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bioproduction</dc:creator>
  <cp:lastModifiedBy>bioproduction</cp:lastModifiedBy>
  <cp:revision>1</cp:revision>
  <dcterms:created xsi:type="dcterms:W3CDTF">2016-01-05T10:18:07Z</dcterms:created>
  <dcterms:modified xsi:type="dcterms:W3CDTF">2016-01-05T10:20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